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5"/>
  </p:notesMasterIdLst>
  <p:sldIdLst>
    <p:sldId id="263" r:id="rId2"/>
    <p:sldId id="264" r:id="rId3"/>
    <p:sldId id="277" r:id="rId4"/>
  </p:sldIdLst>
  <p:sldSz cx="12192000" cy="16256000"/>
  <p:notesSz cx="6858000" cy="9144000"/>
  <p:embeddedFontLs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320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5" Type="http://schemas.openxmlformats.org/officeDocument/2006/relationships/notesMaster" Target="notesMasters/notesMaster1.xml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Google Shape;332;p3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dirty="0"/>
          </a:p>
        </p:txBody>
      </p:sp>
      <p:sp>
        <p:nvSpPr>
          <p:cNvPr id="333" name="Google Shape;333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8491299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Google Shape;353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54" name="Google Shape;35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3969434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openxmlformats.org/officeDocument/2006/relationships/image" Target="../media/image7.png"/><Relationship Id="rId7" Type="http://schemas.openxmlformats.org/officeDocument/2006/relationships/image" Target="../media/image1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emf"/><Relationship Id="rId11" Type="http://schemas.openxmlformats.org/officeDocument/2006/relationships/image" Target="../media/image14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3.tiff"/><Relationship Id="rId4" Type="http://schemas.openxmlformats.org/officeDocument/2006/relationships/image" Target="../media/image8.png"/><Relationship Id="rId9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Google Shape;335;p33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36" name="Google Shape;336;p33"/>
          <p:cNvPicPr preferRelativeResize="0"/>
          <p:nvPr/>
        </p:nvPicPr>
        <p:blipFill rotWithShape="1">
          <a:blip r:embed="rId3">
            <a:alphaModFix/>
          </a:blip>
          <a:srcRect b="66085"/>
          <a:stretch/>
        </p:blipFill>
        <p:spPr>
          <a:xfrm>
            <a:off x="1318591" y="1370988"/>
            <a:ext cx="9064024" cy="1181102"/>
          </a:xfrm>
          <a:prstGeom prst="rect">
            <a:avLst/>
          </a:prstGeom>
          <a:noFill/>
          <a:ln>
            <a:noFill/>
          </a:ln>
        </p:spPr>
      </p:pic>
      <p:sp>
        <p:nvSpPr>
          <p:cNvPr id="337" name="Google Shape;337;p33"/>
          <p:cNvSpPr/>
          <p:nvPr/>
        </p:nvSpPr>
        <p:spPr>
          <a:xfrm>
            <a:off x="5057154" y="1991140"/>
            <a:ext cx="985837" cy="385763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8" name="Google Shape;338;p33"/>
          <p:cNvSpPr txBox="1"/>
          <p:nvPr/>
        </p:nvSpPr>
        <p:spPr>
          <a:xfrm>
            <a:off x="325552" y="1095422"/>
            <a:ext cx="52086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9" name="Google Shape;339;p33"/>
          <p:cNvSpPr txBox="1"/>
          <p:nvPr/>
        </p:nvSpPr>
        <p:spPr>
          <a:xfrm>
            <a:off x="313267" y="3535993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40" name="Google Shape;340;p3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422144" y="2358800"/>
            <a:ext cx="8760665" cy="1227656"/>
          </a:xfrm>
          <a:prstGeom prst="rect">
            <a:avLst/>
          </a:prstGeom>
          <a:noFill/>
          <a:ln>
            <a:noFill/>
          </a:ln>
        </p:spPr>
      </p:pic>
      <p:sp>
        <p:nvSpPr>
          <p:cNvPr id="344" name="Google Shape;344;p33"/>
          <p:cNvSpPr txBox="1"/>
          <p:nvPr/>
        </p:nvSpPr>
        <p:spPr>
          <a:xfrm>
            <a:off x="2196763" y="9709794"/>
            <a:ext cx="839820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Jurkat NLO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5" name="Google Shape;345;p33"/>
          <p:cNvSpPr txBox="1"/>
          <p:nvPr/>
        </p:nvSpPr>
        <p:spPr>
          <a:xfrm>
            <a:off x="2931073" y="9709794"/>
            <a:ext cx="814888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Jurkat Del 1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6" name="Google Shape;346;p33"/>
          <p:cNvSpPr txBox="1"/>
          <p:nvPr/>
        </p:nvSpPr>
        <p:spPr>
          <a:xfrm>
            <a:off x="325552" y="9572675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7" name="Google Shape;347;p33"/>
          <p:cNvSpPr txBox="1"/>
          <p:nvPr/>
        </p:nvSpPr>
        <p:spPr>
          <a:xfrm>
            <a:off x="6088809" y="9629458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48" name="Google Shape;348;p33"/>
          <p:cNvPicPr preferRelativeResize="0"/>
          <p:nvPr/>
        </p:nvPicPr>
        <p:blipFill rotWithShape="1">
          <a:blip r:embed="rId5">
            <a:alphaModFix/>
          </a:blip>
          <a:srcRect l="32410" t="36025" r="46076" b="28803"/>
          <a:stretch/>
        </p:blipFill>
        <p:spPr>
          <a:xfrm>
            <a:off x="1872770" y="10233774"/>
            <a:ext cx="1955380" cy="2540236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49" name="Google Shape;349;p33"/>
          <p:cNvSpPr txBox="1"/>
          <p:nvPr/>
        </p:nvSpPr>
        <p:spPr>
          <a:xfrm>
            <a:off x="3801696" y="10845062"/>
            <a:ext cx="1367551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AL1-long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9 </a:t>
            </a:r>
            <a:r>
              <a:rPr lang="en-US" sz="16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da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0" name="Google Shape;350;p33"/>
          <p:cNvSpPr txBox="1"/>
          <p:nvPr/>
        </p:nvSpPr>
        <p:spPr>
          <a:xfrm>
            <a:off x="3906160" y="11923739"/>
            <a:ext cx="1367551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AL1-short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 Kda</a:t>
            </a:r>
            <a:endParaRPr sz="16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51" name="Google Shape;351;p33"/>
          <p:cNvGraphicFramePr/>
          <p:nvPr>
            <p:extLst>
              <p:ext uri="{D42A27DB-BD31-4B8C-83A1-F6EECF244321}">
                <p14:modId xmlns:p14="http://schemas.microsoft.com/office/powerpoint/2010/main" val="517168633"/>
              </p:ext>
            </p:extLst>
          </p:nvPr>
        </p:nvGraphicFramePr>
        <p:xfrm>
          <a:off x="6678613" y="10248900"/>
          <a:ext cx="3819525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819239" imgH="2744374" progId="Prism8.Document">
                  <p:embed/>
                </p:oleObj>
              </mc:Choice>
              <mc:Fallback>
                <p:oleObj name="Prism 8" r:id="rId6" imgW="3819239" imgH="2744374" progId="Prism8.Document">
                  <p:embed/>
                  <p:pic>
                    <p:nvPicPr>
                      <p:cNvPr id="351" name="Google Shape;351;p33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6678613" y="10248900"/>
                        <a:ext cx="3819525" cy="27463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979B678-48FA-BC1A-2E59-D510744C064D}"/>
              </a:ext>
            </a:extLst>
          </p:cNvPr>
          <p:cNvSpPr txBox="1"/>
          <p:nvPr/>
        </p:nvSpPr>
        <p:spPr>
          <a:xfrm>
            <a:off x="8126096" y="1888630"/>
            <a:ext cx="3941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a-ET" sz="1800" dirty="0">
                <a:solidFill>
                  <a:srgbClr val="FF0000"/>
                </a:solidFill>
              </a:rPr>
              <a:t>*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21B010A-2541-EB4B-8692-7E507CC52567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38" y="3687293"/>
            <a:ext cx="9777171" cy="68440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0A733D6-B211-E048-A255-5A9400E87665}"/>
              </a:ext>
            </a:extLst>
          </p:cNvPr>
          <p:cNvSpPr txBox="1"/>
          <p:nvPr/>
        </p:nvSpPr>
        <p:spPr>
          <a:xfrm>
            <a:off x="9586220" y="309144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1E5A-6FB3-4042-B7CB-3D95874E8176}"/>
              </a:ext>
            </a:extLst>
          </p:cNvPr>
          <p:cNvSpPr txBox="1"/>
          <p:nvPr/>
        </p:nvSpPr>
        <p:spPr>
          <a:xfrm>
            <a:off x="9356595" y="332612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652F124-4D01-374B-9F6C-49B9842312D3}"/>
              </a:ext>
            </a:extLst>
          </p:cNvPr>
          <p:cNvSpPr txBox="1"/>
          <p:nvPr/>
        </p:nvSpPr>
        <p:spPr>
          <a:xfrm>
            <a:off x="8120823" y="310958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54E6032-C6BE-CB4B-8CDE-6DA4B76820A7}"/>
              </a:ext>
            </a:extLst>
          </p:cNvPr>
          <p:cNvSpPr txBox="1"/>
          <p:nvPr/>
        </p:nvSpPr>
        <p:spPr>
          <a:xfrm>
            <a:off x="9065899" y="3103812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9D9D708-C1C0-6448-9BF6-4A153AA9A7A1}"/>
              </a:ext>
            </a:extLst>
          </p:cNvPr>
          <p:cNvSpPr txBox="1"/>
          <p:nvPr/>
        </p:nvSpPr>
        <p:spPr>
          <a:xfrm>
            <a:off x="6105398" y="319743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8120C46-AA31-FD4A-A365-79B75099A0E4}"/>
              </a:ext>
            </a:extLst>
          </p:cNvPr>
          <p:cNvSpPr txBox="1"/>
          <p:nvPr/>
        </p:nvSpPr>
        <p:spPr>
          <a:xfrm>
            <a:off x="2377112" y="376781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113463-0E85-4145-AC5A-9BD6758F5BB7}"/>
              </a:ext>
            </a:extLst>
          </p:cNvPr>
          <p:cNvSpPr txBox="1"/>
          <p:nvPr/>
        </p:nvSpPr>
        <p:spPr>
          <a:xfrm>
            <a:off x="2561720" y="3534097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F982EB8-F53D-7443-AAAE-E6B7BA10E0DF}"/>
              </a:ext>
            </a:extLst>
          </p:cNvPr>
          <p:cNvSpPr txBox="1"/>
          <p:nvPr/>
        </p:nvSpPr>
        <p:spPr>
          <a:xfrm>
            <a:off x="3499648" y="376781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B6381E-D3FA-034F-893C-78D5CC80292C}"/>
              </a:ext>
            </a:extLst>
          </p:cNvPr>
          <p:cNvSpPr txBox="1"/>
          <p:nvPr/>
        </p:nvSpPr>
        <p:spPr>
          <a:xfrm>
            <a:off x="2775388" y="375739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4586DF1-E01E-334D-AACA-36F7B05092ED}"/>
              </a:ext>
            </a:extLst>
          </p:cNvPr>
          <p:cNvSpPr txBox="1"/>
          <p:nvPr/>
        </p:nvSpPr>
        <p:spPr>
          <a:xfrm>
            <a:off x="5446402" y="3840366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A8D6B39-659A-0F95-BCF1-BA060C80CD6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48" t="39197" r="47158" b="48508"/>
          <a:stretch/>
        </p:blipFill>
        <p:spPr>
          <a:xfrm>
            <a:off x="1870473" y="12875319"/>
            <a:ext cx="2009485" cy="99303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Google Shape;531;p22">
            <a:extLst>
              <a:ext uri="{FF2B5EF4-FFF2-40B4-BE49-F238E27FC236}">
                <a16:creationId xmlns:a16="http://schemas.microsoft.com/office/drawing/2014/main" id="{E1E3374C-CBE9-F0AE-FC60-1AA3290A18FA}"/>
              </a:ext>
            </a:extLst>
          </p:cNvPr>
          <p:cNvSpPr txBox="1"/>
          <p:nvPr/>
        </p:nvSpPr>
        <p:spPr>
          <a:xfrm>
            <a:off x="222770" y="13178423"/>
            <a:ext cx="200948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7A73E1-99A1-455A-40E9-F6FB2F2B18FC}"/>
              </a:ext>
            </a:extLst>
          </p:cNvPr>
          <p:cNvSpPr txBox="1"/>
          <p:nvPr/>
        </p:nvSpPr>
        <p:spPr>
          <a:xfrm>
            <a:off x="924802" y="11358790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Google Shape;356;p2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6E08414-09F3-AB44-88FF-BAFC3A177D3C}"/>
              </a:ext>
            </a:extLst>
          </p:cNvPr>
          <p:cNvGrpSpPr/>
          <p:nvPr/>
        </p:nvGrpSpPr>
        <p:grpSpPr>
          <a:xfrm>
            <a:off x="1545191" y="4215821"/>
            <a:ext cx="4132303" cy="3451753"/>
            <a:chOff x="1669311" y="4265611"/>
            <a:chExt cx="4132303" cy="3451753"/>
          </a:xfrm>
        </p:grpSpPr>
        <p:pic>
          <p:nvPicPr>
            <p:cNvPr id="357" name="Google Shape;357;p2"/>
            <p:cNvPicPr preferRelativeResize="0"/>
            <p:nvPr/>
          </p:nvPicPr>
          <p:blipFill rotWithShape="1">
            <a:blip r:embed="rId3">
              <a:alphaModFix/>
            </a:blip>
            <a:srcRect l="12285" t="37811" r="9799" b="33895"/>
            <a:stretch/>
          </p:blipFill>
          <p:spPr>
            <a:xfrm>
              <a:off x="1669311" y="4807273"/>
              <a:ext cx="2919047" cy="1401419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358" name="Google Shape;358;p2"/>
            <p:cNvPicPr preferRelativeResize="0"/>
            <p:nvPr/>
          </p:nvPicPr>
          <p:blipFill rotWithShape="1">
            <a:blip r:embed="rId4">
              <a:alphaModFix/>
            </a:blip>
            <a:srcRect l="6388" t="37396" r="12104" b="27797"/>
            <a:stretch/>
          </p:blipFill>
          <p:spPr>
            <a:xfrm>
              <a:off x="1669311" y="6333857"/>
              <a:ext cx="2919047" cy="1383507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sp>
          <p:nvSpPr>
            <p:cNvPr id="359" name="Google Shape;359;p2"/>
            <p:cNvSpPr txBox="1"/>
            <p:nvPr/>
          </p:nvSpPr>
          <p:spPr>
            <a:xfrm>
              <a:off x="1898552" y="4265611"/>
              <a:ext cx="1230282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HEK293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endParaRPr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0" name="Google Shape;360;p2"/>
            <p:cNvSpPr txBox="1"/>
            <p:nvPr/>
          </p:nvSpPr>
          <p:spPr>
            <a:xfrm>
              <a:off x="3180440" y="4265611"/>
              <a:ext cx="1149563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HEK293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∆CTCF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1" name="Google Shape;361;p2"/>
            <p:cNvSpPr txBox="1"/>
            <p:nvPr/>
          </p:nvSpPr>
          <p:spPr>
            <a:xfrm>
              <a:off x="4425730" y="5215594"/>
              <a:ext cx="1367551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long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9 </a:t>
              </a:r>
              <a:r>
                <a:rPr lang="en-US" sz="1600" b="0" i="0" u="none" strike="noStrike" cap="none" dirty="0" err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da</a:t>
              </a:r>
              <a:endParaRPr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2" name="Google Shape;362;p2"/>
            <p:cNvSpPr txBox="1"/>
            <p:nvPr/>
          </p:nvSpPr>
          <p:spPr>
            <a:xfrm>
              <a:off x="4434063" y="6539789"/>
              <a:ext cx="1367551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7 </a:t>
              </a:r>
              <a:r>
                <a:rPr lang="en-US" sz="1600" b="0" i="0" u="none" strike="noStrike" cap="none" dirty="0" err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da</a:t>
              </a:r>
              <a:endParaRPr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64" name="Google Shape;364;p2"/>
          <p:cNvSpPr txBox="1"/>
          <p:nvPr/>
        </p:nvSpPr>
        <p:spPr>
          <a:xfrm>
            <a:off x="127895" y="3798614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5" name="Google Shape;365;p2"/>
          <p:cNvSpPr txBox="1"/>
          <p:nvPr/>
        </p:nvSpPr>
        <p:spPr>
          <a:xfrm>
            <a:off x="6013932" y="3806881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7" name="Google Shape;367;p2"/>
          <p:cNvSpPr txBox="1"/>
          <p:nvPr/>
        </p:nvSpPr>
        <p:spPr>
          <a:xfrm>
            <a:off x="162391" y="352860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8" name="Google Shape;368;p2"/>
          <p:cNvSpPr txBox="1"/>
          <p:nvPr/>
        </p:nvSpPr>
        <p:spPr>
          <a:xfrm>
            <a:off x="194748" y="10877099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9" name="Google Shape;369;p2"/>
          <p:cNvSpPr txBox="1"/>
          <p:nvPr/>
        </p:nvSpPr>
        <p:spPr>
          <a:xfrm>
            <a:off x="6080785" y="10877099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4" name="Google Shape;363;p2">
            <a:extLst>
              <a:ext uri="{FF2B5EF4-FFF2-40B4-BE49-F238E27FC236}">
                <a16:creationId xmlns:a16="http://schemas.microsoft.com/office/drawing/2014/main" id="{A04CFFD9-6670-5D44-ABED-94D23B17909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76500811"/>
              </p:ext>
            </p:extLst>
          </p:nvPr>
        </p:nvGraphicFramePr>
        <p:xfrm>
          <a:off x="5707601" y="4131411"/>
          <a:ext cx="6612294" cy="3534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177311" imgH="2453009" progId="Prism8.Document">
                  <p:embed/>
                </p:oleObj>
              </mc:Choice>
              <mc:Fallback>
                <p:oleObj name="Prism 8" r:id="rId5" imgW="5177311" imgH="2453009" progId="Prism8.Document">
                  <p:embed/>
                  <p:pic>
                    <p:nvPicPr>
                      <p:cNvPr id="3" name="Google Shape;363;p2">
                        <a:extLst>
                          <a:ext uri="{FF2B5EF4-FFF2-40B4-BE49-F238E27FC236}">
                            <a16:creationId xmlns:a16="http://schemas.microsoft.com/office/drawing/2014/main" id="{208845F9-C938-8A4E-BDA5-ACAA7A4C3CDA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5707601" y="4131411"/>
                        <a:ext cx="6612294" cy="353464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B409530C-39A4-2241-80DE-482EC0AADFB1}"/>
              </a:ext>
            </a:extLst>
          </p:cNvPr>
          <p:cNvGrpSpPr/>
          <p:nvPr/>
        </p:nvGrpSpPr>
        <p:grpSpPr>
          <a:xfrm>
            <a:off x="198589" y="11189853"/>
            <a:ext cx="4601796" cy="3561896"/>
            <a:chOff x="39448" y="3979330"/>
            <a:chExt cx="4601796" cy="3561896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F42F4210-6904-BC4F-B566-2F9B57E72D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16" t="27905" r="44898" b="64243"/>
            <a:stretch/>
          </p:blipFill>
          <p:spPr>
            <a:xfrm>
              <a:off x="1810310" y="5099975"/>
              <a:ext cx="2451308" cy="121986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4" name="Google Shape;531;p22">
              <a:extLst>
                <a:ext uri="{FF2B5EF4-FFF2-40B4-BE49-F238E27FC236}">
                  <a16:creationId xmlns:a16="http://schemas.microsoft.com/office/drawing/2014/main" id="{F32953B2-F3E8-FF45-B2C0-527E7E8FF0C2}"/>
                </a:ext>
              </a:extLst>
            </p:cNvPr>
            <p:cNvSpPr txBox="1"/>
            <p:nvPr/>
          </p:nvSpPr>
          <p:spPr>
            <a:xfrm>
              <a:off x="788748" y="5479094"/>
              <a:ext cx="2386562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2400" b="1" dirty="0">
                  <a:solidFill>
                    <a:schemeClr val="dk1"/>
                  </a:solidFill>
                  <a:ea typeface="Arial"/>
                  <a:cs typeface="Arial"/>
                  <a:sym typeface="Arial"/>
                </a:rPr>
                <a:t>Cas9</a:t>
              </a:r>
              <a:endParaRPr sz="2400" dirty="0"/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9D1784B-54BD-BE43-8785-BAB6C6A085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97" t="51997" r="44761" b="40938"/>
            <a:stretch/>
          </p:blipFill>
          <p:spPr>
            <a:xfrm>
              <a:off x="1810310" y="6509033"/>
              <a:ext cx="2418003" cy="10321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2985CE8-84E0-4A49-923E-D2A07EC99ABA}"/>
                </a:ext>
              </a:extLst>
            </p:cNvPr>
            <p:cNvSpPr txBox="1"/>
            <p:nvPr/>
          </p:nvSpPr>
          <p:spPr>
            <a:xfrm>
              <a:off x="1567725" y="4397690"/>
              <a:ext cx="1794933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6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Cas9 p300 core (mut) </a:t>
              </a:r>
              <a:endParaRPr lang="en-IN" sz="16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B138DB9-D779-D444-8D74-E33346ABC578}"/>
                </a:ext>
              </a:extLst>
            </p:cNvPr>
            <p:cNvSpPr txBox="1"/>
            <p:nvPr/>
          </p:nvSpPr>
          <p:spPr>
            <a:xfrm>
              <a:off x="3127323" y="4409285"/>
              <a:ext cx="1513921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6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Cas9 p300 core (WT) </a:t>
              </a:r>
              <a:endParaRPr lang="en-IN" sz="1600" dirty="0"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lang="en-IN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2" name="Google Shape;531;p22">
              <a:extLst>
                <a:ext uri="{FF2B5EF4-FFF2-40B4-BE49-F238E27FC236}">
                  <a16:creationId xmlns:a16="http://schemas.microsoft.com/office/drawing/2014/main" id="{9DB71749-6D08-F541-AE62-0BF237F6BC91}"/>
                </a:ext>
              </a:extLst>
            </p:cNvPr>
            <p:cNvSpPr txBox="1"/>
            <p:nvPr/>
          </p:nvSpPr>
          <p:spPr>
            <a:xfrm>
              <a:off x="39448" y="6835969"/>
              <a:ext cx="2009485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lvl="0"/>
              <a:r>
                <a:rPr lang="el-GR" sz="2400" b="1" dirty="0"/>
                <a:t>α</a:t>
              </a:r>
              <a:r>
                <a:rPr lang="en-US" sz="2400" b="1" dirty="0"/>
                <a:t>- Tubulin</a:t>
              </a:r>
              <a:endParaRPr sz="2400" b="1" dirty="0"/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3ECE4D71-CCEF-334C-B7F9-84106F1A610D}"/>
                </a:ext>
              </a:extLst>
            </p:cNvPr>
            <p:cNvCxnSpPr/>
            <p:nvPr/>
          </p:nvCxnSpPr>
          <p:spPr>
            <a:xfrm>
              <a:off x="1810310" y="4447655"/>
              <a:ext cx="283093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2AED2AC-DFA5-5947-8D5E-755CD40F215E}"/>
                </a:ext>
              </a:extLst>
            </p:cNvPr>
            <p:cNvSpPr txBox="1"/>
            <p:nvPr/>
          </p:nvSpPr>
          <p:spPr>
            <a:xfrm>
              <a:off x="1810310" y="3979330"/>
              <a:ext cx="259235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L" sz="2400" dirty="0"/>
                <a:t>HEK293T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ECFCF51F-64E9-FF3B-EDCD-58A94E5F9F3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44" t="58338" r="38574" b="31259"/>
          <a:stretch/>
        </p:blipFill>
        <p:spPr>
          <a:xfrm>
            <a:off x="1545191" y="7814194"/>
            <a:ext cx="2967141" cy="126103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Google Shape;531;p22">
            <a:extLst>
              <a:ext uri="{FF2B5EF4-FFF2-40B4-BE49-F238E27FC236}">
                <a16:creationId xmlns:a16="http://schemas.microsoft.com/office/drawing/2014/main" id="{083132B8-93AB-BB1E-D5C7-DB30E4733714}"/>
              </a:ext>
            </a:extLst>
          </p:cNvPr>
          <p:cNvSpPr txBox="1"/>
          <p:nvPr/>
        </p:nvSpPr>
        <p:spPr>
          <a:xfrm>
            <a:off x="-40034" y="8273526"/>
            <a:ext cx="200948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75410B-1062-6CBC-495E-8F61AA19D07D}"/>
              </a:ext>
            </a:extLst>
          </p:cNvPr>
          <p:cNvSpPr txBox="1"/>
          <p:nvPr/>
        </p:nvSpPr>
        <p:spPr>
          <a:xfrm>
            <a:off x="422821" y="6024173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D2E103A-97BB-228E-FBD3-471C1E0D7C4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4361" y="11334557"/>
            <a:ext cx="5526155" cy="353462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4976521-EF65-4E45-8383-600DA4B25F3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44601"/>
          <a:stretch/>
        </p:blipFill>
        <p:spPr>
          <a:xfrm>
            <a:off x="223185" y="-109452"/>
            <a:ext cx="10691981" cy="4146261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372;p2">
            <a:extLst>
              <a:ext uri="{FF2B5EF4-FFF2-40B4-BE49-F238E27FC236}">
                <a16:creationId xmlns:a16="http://schemas.microsoft.com/office/drawing/2014/main" id="{66132B05-3377-7D49-920B-BDB77E4A5BC1}"/>
              </a:ext>
            </a:extLst>
          </p:cNvPr>
          <p:cNvSpPr txBox="1"/>
          <p:nvPr/>
        </p:nvSpPr>
        <p:spPr>
          <a:xfrm>
            <a:off x="568654" y="9133193"/>
            <a:ext cx="10673691" cy="50167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2: A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Sequencing of 5’ RACE PCR in Jurkat cells aligned to TAL1 locus. Peaks mark the sequence of the 5’ UTR. Red asterisk marks a peak that did not align to any known TSS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B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chematic representation of TAL1 mRNA isoforms. Rectangles: exons, black lines: introns; arrow: transcription initiation site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&amp;D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whole cell lysate was extracted from Jurkat NLO cells, expressing TAL1 exogenously, and enhancer mutated cells Jurkat Del-12 , and subjected to western blot analysis using the indicated antibodies (S2_Data) (C). RNA was extracted and real-time PCR was conducted TAL1 promoter relative to to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ycloA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D). </a:t>
            </a:r>
            <a:r>
              <a:rPr lang="en-US" sz="1600" b="1" dirty="0">
                <a:solidFill>
                  <a:schemeClr val="tx1"/>
                </a:solidFill>
              </a:rPr>
              <a:t>E.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chematic representation of TAL1 genomic locus. Rectangles: exons, black lines: introns, arrow: transcription initiation site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F-H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Whole cell lysate was extracted from HEK293T cells and CTCF mutated cells, HEK293T ∆CTCF, and subjected to western blot analysis using the indicated antibodies (S2_Data) (F). RNA was extracted and analyzed by real-time PCR for each of TAL1’s promoters relative to CycloA and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G)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EK293T cells were transfected with either dCas9-p300 core (mut) or dCas9-p300 core (WT) with four gRNAs targeted to the TAL1 -60 enhancer for 30 h. Whole cell lysate was extracted and subjected to Western blot analysis using the indicated antibodies (S2_Data) 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I&amp;</a:t>
            </a:r>
            <a:r>
              <a:rPr lang="en-US" sz="1600" b="1" dirty="0">
                <a:solidFill>
                  <a:schemeClr val="tx1"/>
                </a:solidFill>
              </a:rPr>
              <a:t>J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Jurkat cells were transfected with siKMT2B or a negative control siRNA (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iGF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), and RNA was extracted 72 hours post-transfection. Real-time PCR was performed to KMT2B total mRNA amount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I) and total mRNA amount of TAL1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J). 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The mean was calculated from three independent biological experiments, each performed with three technical replicates.</a:t>
            </a:r>
            <a:r>
              <a:rPr lang="en-US" sz="1600" dirty="0">
                <a:solidFill>
                  <a:schemeClr val="tx1"/>
                </a:solidFill>
              </a:rPr>
              <a:t>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K-M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Jurkat cells were treated with 6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μM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CPT for 6 h and analyzed by real-time PCR for total mRNA amount of CycloA relative to 18S reference gene transcribed by Polymerase I (K) and TAL1 relative to 18S reference gene (L) and for ∆Ex3 relative to TAL1 total mRNA amount. PSI was calculated by ∆Ex3 relative to TAL1 total mRNA (S1_Data) (M). </a:t>
            </a:r>
            <a:endParaRPr sz="16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445;p4">
            <a:extLst>
              <a:ext uri="{FF2B5EF4-FFF2-40B4-BE49-F238E27FC236}">
                <a16:creationId xmlns:a16="http://schemas.microsoft.com/office/drawing/2014/main" id="{71A51A94-6111-3546-8278-DB2E45947B62}"/>
              </a:ext>
            </a:extLst>
          </p:cNvPr>
          <p:cNvSpPr txBox="1"/>
          <p:nvPr/>
        </p:nvSpPr>
        <p:spPr>
          <a:xfrm>
            <a:off x="204295" y="267722"/>
            <a:ext cx="349236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J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446;p4">
            <a:extLst>
              <a:ext uri="{FF2B5EF4-FFF2-40B4-BE49-F238E27FC236}">
                <a16:creationId xmlns:a16="http://schemas.microsoft.com/office/drawing/2014/main" id="{BDC93E58-5590-8F4A-A82E-71A602A072BD}"/>
              </a:ext>
            </a:extLst>
          </p:cNvPr>
          <p:cNvSpPr txBox="1"/>
          <p:nvPr/>
        </p:nvSpPr>
        <p:spPr>
          <a:xfrm>
            <a:off x="5905500" y="136020"/>
            <a:ext cx="1595909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K</a:t>
            </a:r>
            <a:endParaRPr dirty="0"/>
          </a:p>
        </p:txBody>
      </p:sp>
      <p:sp>
        <p:nvSpPr>
          <p:cNvPr id="16" name="Google Shape;487;p5">
            <a:extLst>
              <a:ext uri="{FF2B5EF4-FFF2-40B4-BE49-F238E27FC236}">
                <a16:creationId xmlns:a16="http://schemas.microsoft.com/office/drawing/2014/main" id="{FE3EB151-BDCC-F14F-BF7A-8E0880A8653B}"/>
              </a:ext>
            </a:extLst>
          </p:cNvPr>
          <p:cNvSpPr txBox="1"/>
          <p:nvPr/>
        </p:nvSpPr>
        <p:spPr>
          <a:xfrm>
            <a:off x="5905500" y="4504461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M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" name="Google Shape;409;p36">
            <a:extLst>
              <a:ext uri="{FF2B5EF4-FFF2-40B4-BE49-F238E27FC236}">
                <a16:creationId xmlns:a16="http://schemas.microsoft.com/office/drawing/2014/main" id="{965D75D5-BD9D-AD40-8BC4-525750DD405F}"/>
              </a:ext>
            </a:extLst>
          </p:cNvPr>
          <p:cNvSpPr txBox="1"/>
          <p:nvPr/>
        </p:nvSpPr>
        <p:spPr>
          <a:xfrm>
            <a:off x="217525" y="450446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L</a:t>
            </a:r>
            <a:endParaRPr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33BE30F-012A-DCA8-84FD-193DDDDA006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654" y="263527"/>
            <a:ext cx="5479647" cy="35048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A711E5F-2D72-78D4-CA62-47E7E71037A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392" y="510247"/>
            <a:ext cx="4993953" cy="319168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36B763-547B-C850-DAC9-76832E68BF42}"/>
              </a:ext>
            </a:extLst>
          </p:cNvPr>
          <p:cNvSpPr txBox="1"/>
          <p:nvPr/>
        </p:nvSpPr>
        <p:spPr>
          <a:xfrm rot="16200000">
            <a:off x="5338621" y="2090484"/>
            <a:ext cx="2421891" cy="30777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R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</a:pPr>
            <a:r>
              <a:rPr lang="en-US" b="1" dirty="0"/>
              <a:t>Cyclo A total mRNA</a:t>
            </a:r>
            <a:endParaRPr lang="en-IL" b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769EC82-3582-7961-C898-EF4F221608F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189" y="4916676"/>
            <a:ext cx="4693071" cy="30017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D5F68F1-811F-2C07-0A75-2DF91FD0AC2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799" y="4798687"/>
            <a:ext cx="4881417" cy="3119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3916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4</TotalTime>
  <Words>523</Words>
  <Application>Microsoft Macintosh PowerPoint</Application>
  <PresentationFormat>Custom</PresentationFormat>
  <Paragraphs>50</Paragraphs>
  <Slides>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 Theme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03T10:32:43Z</dcterms:modified>
</cp:coreProperties>
</file>